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0"/>
  </p:notesMasterIdLst>
  <p:sldIdLst>
    <p:sldId id="362" r:id="rId2"/>
    <p:sldId id="377" r:id="rId3"/>
    <p:sldId id="374" r:id="rId4"/>
    <p:sldId id="375" r:id="rId5"/>
    <p:sldId id="376" r:id="rId6"/>
    <p:sldId id="311" r:id="rId7"/>
    <p:sldId id="370" r:id="rId8"/>
    <p:sldId id="371" r:id="rId9"/>
  </p:sldIdLst>
  <p:sldSz cx="6480175" cy="9144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기본 구역" id="{9599C681-350A-4532-B1BC-DBB55E2946F2}">
          <p14:sldIdLst>
            <p14:sldId id="362"/>
            <p14:sldId id="377"/>
            <p14:sldId id="374"/>
            <p14:sldId id="375"/>
            <p14:sldId id="376"/>
            <p14:sldId id="311"/>
            <p14:sldId id="370"/>
            <p14:sldId id="37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903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eunghyun Ban" initials="SB" lastIdx="1" clrIdx="0">
    <p:extLst>
      <p:ext uri="{19B8F6BF-5375-455C-9EA6-DF929625EA0E}">
        <p15:presenceInfo xmlns:p15="http://schemas.microsoft.com/office/powerpoint/2012/main" userId="S-1-5-21-664833317-144702349-4049103145-100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E0605"/>
    <a:srgbClr val="FFFFFF"/>
    <a:srgbClr val="F0B4A2"/>
    <a:srgbClr val="F17766"/>
    <a:srgbClr val="FBEBE6"/>
    <a:srgbClr val="EFB3A0"/>
    <a:srgbClr val="0000FF"/>
    <a:srgbClr val="FF7F00"/>
    <a:srgbClr val="377EB8"/>
    <a:srgbClr val="A656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514" autoAdjust="0"/>
    <p:restoredTop sz="76923" autoAdjust="0"/>
  </p:normalViewPr>
  <p:slideViewPr>
    <p:cSldViewPr snapToGrid="0" showGuides="1">
      <p:cViewPr varScale="1">
        <p:scale>
          <a:sx n="43" d="100"/>
          <a:sy n="43" d="100"/>
        </p:scale>
        <p:origin x="2964" y="66"/>
      </p:cViewPr>
      <p:guideLst>
        <p:guide orient="horz" pos="2903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3C2B68-5107-46A9-BDAB-42FB0B752410}" type="datetimeFigureOut">
              <a:rPr lang="ko-KR" altLang="en-US" smtClean="0"/>
              <a:t>2023-04-1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11388" y="1241425"/>
            <a:ext cx="237490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ED8AE9-BE61-48D7-8472-85924D971D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55242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atinLnBrk="0"/>
            <a:endParaRPr lang="ko-KR" altLang="ko-K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ED8AE9-BE61-48D7-8472-85924D971D91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98437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atinLnBrk="0"/>
            <a:endParaRPr lang="ko-KR" altLang="ko-K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ED8AE9-BE61-48D7-8472-85924D971D91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655378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atinLnBrk="0"/>
            <a:endParaRPr lang="ko-KR" altLang="ko-K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ED8AE9-BE61-48D7-8472-85924D971D91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205141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atinLnBrk="0"/>
            <a:endParaRPr lang="ko-KR" altLang="ko-K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ED8AE9-BE61-48D7-8472-85924D971D91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689682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atinLnBrk="0"/>
            <a:endParaRPr lang="ko-KR" altLang="ko-K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ED8AE9-BE61-48D7-8472-85924D971D91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98997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496484"/>
            <a:ext cx="5508149" cy="3183467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802717"/>
            <a:ext cx="4860131" cy="2207683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6E98F-D75D-470C-A5F3-16053C3B78B7}" type="datetimeFigureOut">
              <a:rPr lang="ko-KR" altLang="en-US" smtClean="0"/>
              <a:t>2023-04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7E4DD-F937-430C-8B2A-DEA3251C1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0829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6E98F-D75D-470C-A5F3-16053C3B78B7}" type="datetimeFigureOut">
              <a:rPr lang="ko-KR" altLang="en-US" smtClean="0"/>
              <a:t>2023-04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7E4DD-F937-430C-8B2A-DEA3251C1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2564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86834"/>
            <a:ext cx="1397288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86834"/>
            <a:ext cx="4110861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6E98F-D75D-470C-A5F3-16053C3B78B7}" type="datetimeFigureOut">
              <a:rPr lang="ko-KR" altLang="en-US" smtClean="0"/>
              <a:t>2023-04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7E4DD-F937-430C-8B2A-DEA3251C1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3157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6E98F-D75D-470C-A5F3-16053C3B78B7}" type="datetimeFigureOut">
              <a:rPr lang="ko-KR" altLang="en-US" smtClean="0"/>
              <a:t>2023-04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7E4DD-F937-430C-8B2A-DEA3251C1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6985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279653"/>
            <a:ext cx="5589151" cy="3803649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119286"/>
            <a:ext cx="5589151" cy="2000249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6E98F-D75D-470C-A5F3-16053C3B78B7}" type="datetimeFigureOut">
              <a:rPr lang="ko-KR" altLang="en-US" smtClean="0"/>
              <a:t>2023-04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7E4DD-F937-430C-8B2A-DEA3251C1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3035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434167"/>
            <a:ext cx="2754074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434167"/>
            <a:ext cx="2754074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6E98F-D75D-470C-A5F3-16053C3B78B7}" type="datetimeFigureOut">
              <a:rPr lang="ko-KR" altLang="en-US" smtClean="0"/>
              <a:t>2023-04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7E4DD-F937-430C-8B2A-DEA3251C1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2564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86836"/>
            <a:ext cx="5589151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241551"/>
            <a:ext cx="2741417" cy="1098549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340100"/>
            <a:ext cx="2741417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241551"/>
            <a:ext cx="2754918" cy="1098549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340100"/>
            <a:ext cx="2754918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6E98F-D75D-470C-A5F3-16053C3B78B7}" type="datetimeFigureOut">
              <a:rPr lang="ko-KR" altLang="en-US" smtClean="0"/>
              <a:t>2023-04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7E4DD-F937-430C-8B2A-DEA3251C1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298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6E98F-D75D-470C-A5F3-16053C3B78B7}" type="datetimeFigureOut">
              <a:rPr lang="ko-KR" altLang="en-US" smtClean="0"/>
              <a:t>2023-04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7E4DD-F937-430C-8B2A-DEA3251C1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26737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6E98F-D75D-470C-A5F3-16053C3B78B7}" type="datetimeFigureOut">
              <a:rPr lang="ko-KR" altLang="en-US" smtClean="0"/>
              <a:t>2023-04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7E4DD-F937-430C-8B2A-DEA3251C1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1253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09600"/>
            <a:ext cx="2090025" cy="21336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316569"/>
            <a:ext cx="3280589" cy="6498167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743200"/>
            <a:ext cx="2090025" cy="508211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6E98F-D75D-470C-A5F3-16053C3B78B7}" type="datetimeFigureOut">
              <a:rPr lang="ko-KR" altLang="en-US" smtClean="0"/>
              <a:t>2023-04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7E4DD-F937-430C-8B2A-DEA3251C1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9976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09600"/>
            <a:ext cx="2090025" cy="21336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316569"/>
            <a:ext cx="3280589" cy="6498167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743200"/>
            <a:ext cx="2090025" cy="508211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6E98F-D75D-470C-A5F3-16053C3B78B7}" type="datetimeFigureOut">
              <a:rPr lang="ko-KR" altLang="en-US" smtClean="0"/>
              <a:t>2023-04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7E4DD-F937-430C-8B2A-DEA3251C1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47770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86836"/>
            <a:ext cx="5589151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434167"/>
            <a:ext cx="5589151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8475136"/>
            <a:ext cx="145803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86E98F-D75D-470C-A5F3-16053C3B78B7}" type="datetimeFigureOut">
              <a:rPr lang="ko-KR" altLang="en-US" smtClean="0"/>
              <a:t>2023-04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8475136"/>
            <a:ext cx="218705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8475136"/>
            <a:ext cx="145803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F7E4DD-F937-430C-8B2A-DEA3251C19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6703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48035" rtl="0" eaLnBrk="1" latinLnBrk="1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1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1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jpg"/><Relationship Id="rId5" Type="http://schemas.openxmlformats.org/officeDocument/2006/relationships/image" Target="../media/image5.jp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C95D42E-6162-4349-9E32-EA1E16FCF229}"/>
              </a:ext>
            </a:extLst>
          </p:cNvPr>
          <p:cNvSpPr txBox="1"/>
          <p:nvPr/>
        </p:nvSpPr>
        <p:spPr>
          <a:xfrm>
            <a:off x="1252718" y="3878987"/>
            <a:ext cx="39747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800" dirty="0"/>
              <a:t>Supplementary figures</a:t>
            </a:r>
            <a:endParaRPr lang="ko-KR" altLang="en-US" sz="2800" dirty="0"/>
          </a:p>
        </p:txBody>
      </p:sp>
    </p:spTree>
    <p:extLst>
      <p:ext uri="{BB962C8B-B14F-4D97-AF65-F5344CB8AC3E}">
        <p14:creationId xmlns:p14="http://schemas.microsoft.com/office/powerpoint/2010/main" val="5773384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그룹 59">
            <a:extLst>
              <a:ext uri="{FF2B5EF4-FFF2-40B4-BE49-F238E27FC236}">
                <a16:creationId xmlns:a16="http://schemas.microsoft.com/office/drawing/2014/main" id="{888A893D-040D-7311-7F51-28FE2BDD3D5E}"/>
              </a:ext>
            </a:extLst>
          </p:cNvPr>
          <p:cNvGrpSpPr/>
          <p:nvPr/>
        </p:nvGrpSpPr>
        <p:grpSpPr>
          <a:xfrm>
            <a:off x="465208" y="977879"/>
            <a:ext cx="3906763" cy="3888000"/>
            <a:chOff x="465208" y="977879"/>
            <a:chExt cx="3906763" cy="3888000"/>
          </a:xfrm>
        </p:grpSpPr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D5F438B6-A3B6-7452-1CA4-75283EE840EF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5208" y="977879"/>
              <a:ext cx="2592000" cy="19440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7ACB3E0-9CEC-60E9-EB0A-3091C6358F22}"/>
                </a:ext>
              </a:extLst>
            </p:cNvPr>
            <p:cNvSpPr txBox="1"/>
            <p:nvPr/>
          </p:nvSpPr>
          <p:spPr>
            <a:xfrm>
              <a:off x="465208" y="977879"/>
              <a:ext cx="5150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2C7D4AA5-3203-8763-8461-71203651CC7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5208" y="2921879"/>
              <a:ext cx="2592000" cy="194400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BF2046A-2BED-95D5-165F-77E04772FD10}"/>
                </a:ext>
              </a:extLst>
            </p:cNvPr>
            <p:cNvSpPr txBox="1"/>
            <p:nvPr/>
          </p:nvSpPr>
          <p:spPr>
            <a:xfrm>
              <a:off x="465208" y="2921879"/>
              <a:ext cx="5150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DBF4A87-10B0-A323-CC9B-B9ABB73E369C}"/>
                </a:ext>
              </a:extLst>
            </p:cNvPr>
            <p:cNvSpPr txBox="1"/>
            <p:nvPr/>
          </p:nvSpPr>
          <p:spPr>
            <a:xfrm>
              <a:off x="3107527" y="1446402"/>
              <a:ext cx="10715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Ridge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F3D21A7E-0ACE-7B0E-F879-6635129D0725}"/>
                </a:ext>
              </a:extLst>
            </p:cNvPr>
            <p:cNvCxnSpPr>
              <a:cxnSpLocks/>
            </p:cNvCxnSpPr>
            <p:nvPr/>
          </p:nvCxnSpPr>
          <p:spPr>
            <a:xfrm>
              <a:off x="2305050" y="1562894"/>
              <a:ext cx="85486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직선 연결선 13">
              <a:extLst>
                <a:ext uri="{FF2B5EF4-FFF2-40B4-BE49-F238E27FC236}">
                  <a16:creationId xmlns:a16="http://schemas.microsoft.com/office/drawing/2014/main" id="{10CC15C5-E75A-1969-1B0A-D69647D46723}"/>
                </a:ext>
              </a:extLst>
            </p:cNvPr>
            <p:cNvCxnSpPr>
              <a:cxnSpLocks/>
            </p:cNvCxnSpPr>
            <p:nvPr/>
          </p:nvCxnSpPr>
          <p:spPr>
            <a:xfrm>
              <a:off x="2306240" y="1772444"/>
              <a:ext cx="85486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1049CEF-2A5A-A2C3-BEF1-C35029066B65}"/>
                </a:ext>
              </a:extLst>
            </p:cNvPr>
            <p:cNvSpPr txBox="1"/>
            <p:nvPr/>
          </p:nvSpPr>
          <p:spPr>
            <a:xfrm>
              <a:off x="3107527" y="1649335"/>
              <a:ext cx="10715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Groove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직선 연결선 15">
              <a:extLst>
                <a:ext uri="{FF2B5EF4-FFF2-40B4-BE49-F238E27FC236}">
                  <a16:creationId xmlns:a16="http://schemas.microsoft.com/office/drawing/2014/main" id="{509998DA-5768-15F6-6667-39EC33F0B313}"/>
                </a:ext>
              </a:extLst>
            </p:cNvPr>
            <p:cNvCxnSpPr>
              <a:cxnSpLocks/>
            </p:cNvCxnSpPr>
            <p:nvPr/>
          </p:nvCxnSpPr>
          <p:spPr>
            <a:xfrm>
              <a:off x="2190750" y="2151370"/>
              <a:ext cx="97035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직선 연결선 18">
              <a:extLst>
                <a:ext uri="{FF2B5EF4-FFF2-40B4-BE49-F238E27FC236}">
                  <a16:creationId xmlns:a16="http://schemas.microsoft.com/office/drawing/2014/main" id="{CBA7ED55-F9FB-3E24-EE38-7A49919BEE76}"/>
                </a:ext>
              </a:extLst>
            </p:cNvPr>
            <p:cNvCxnSpPr>
              <a:cxnSpLocks/>
            </p:cNvCxnSpPr>
            <p:nvPr/>
          </p:nvCxnSpPr>
          <p:spPr>
            <a:xfrm>
              <a:off x="1802606" y="1975670"/>
              <a:ext cx="135850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948662D-E868-E279-5D5E-9BEA17E476EF}"/>
                </a:ext>
              </a:extLst>
            </p:cNvPr>
            <p:cNvSpPr txBox="1"/>
            <p:nvPr/>
          </p:nvSpPr>
          <p:spPr>
            <a:xfrm>
              <a:off x="3107527" y="1866557"/>
              <a:ext cx="10715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Pith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직선 연결선 22">
              <a:extLst>
                <a:ext uri="{FF2B5EF4-FFF2-40B4-BE49-F238E27FC236}">
                  <a16:creationId xmlns:a16="http://schemas.microsoft.com/office/drawing/2014/main" id="{6BC2F352-ABE8-AA0D-67A2-F30BBC68F642}"/>
                </a:ext>
              </a:extLst>
            </p:cNvPr>
            <p:cNvCxnSpPr>
              <a:cxnSpLocks/>
            </p:cNvCxnSpPr>
            <p:nvPr/>
          </p:nvCxnSpPr>
          <p:spPr>
            <a:xfrm>
              <a:off x="2226469" y="2351984"/>
              <a:ext cx="93464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6E2F979-6C5A-1820-BAE8-BBC44867A97C}"/>
                </a:ext>
              </a:extLst>
            </p:cNvPr>
            <p:cNvSpPr txBox="1"/>
            <p:nvPr/>
          </p:nvSpPr>
          <p:spPr>
            <a:xfrm>
              <a:off x="3107527" y="2242871"/>
              <a:ext cx="10715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Epidermis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42BB304-924E-0C6B-91CF-1C9349F781D9}"/>
                </a:ext>
              </a:extLst>
            </p:cNvPr>
            <p:cNvSpPr txBox="1"/>
            <p:nvPr/>
          </p:nvSpPr>
          <p:spPr>
            <a:xfrm>
              <a:off x="3107527" y="2034325"/>
              <a:ext cx="12644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Collateral bundle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직선 연결선 36">
              <a:extLst>
                <a:ext uri="{FF2B5EF4-FFF2-40B4-BE49-F238E27FC236}">
                  <a16:creationId xmlns:a16="http://schemas.microsoft.com/office/drawing/2014/main" id="{924AC114-829A-CABF-1C58-F0A006337FD0}"/>
                </a:ext>
              </a:extLst>
            </p:cNvPr>
            <p:cNvCxnSpPr>
              <a:cxnSpLocks/>
            </p:cNvCxnSpPr>
            <p:nvPr/>
          </p:nvCxnSpPr>
          <p:spPr>
            <a:xfrm>
              <a:off x="2262188" y="2550717"/>
              <a:ext cx="89892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EC5CB16-9B23-CCD2-D758-9846C650B64A}"/>
                </a:ext>
              </a:extLst>
            </p:cNvPr>
            <p:cNvSpPr txBox="1"/>
            <p:nvPr/>
          </p:nvSpPr>
          <p:spPr>
            <a:xfrm>
              <a:off x="3107527" y="2441604"/>
              <a:ext cx="10715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Trichome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직선 연결선 40">
              <a:extLst>
                <a:ext uri="{FF2B5EF4-FFF2-40B4-BE49-F238E27FC236}">
                  <a16:creationId xmlns:a16="http://schemas.microsoft.com/office/drawing/2014/main" id="{8B52B827-F990-A86C-AD09-1C474AEA96FD}"/>
                </a:ext>
              </a:extLst>
            </p:cNvPr>
            <p:cNvCxnSpPr>
              <a:cxnSpLocks/>
            </p:cNvCxnSpPr>
            <p:nvPr/>
          </p:nvCxnSpPr>
          <p:spPr>
            <a:xfrm>
              <a:off x="2576513" y="3322242"/>
              <a:ext cx="58459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EE9F977D-F083-359E-2EFC-33D343296A80}"/>
                </a:ext>
              </a:extLst>
            </p:cNvPr>
            <p:cNvSpPr txBox="1"/>
            <p:nvPr/>
          </p:nvSpPr>
          <p:spPr>
            <a:xfrm>
              <a:off x="3107527" y="3213129"/>
              <a:ext cx="10715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Epidermis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직사각형 42">
              <a:extLst>
                <a:ext uri="{FF2B5EF4-FFF2-40B4-BE49-F238E27FC236}">
                  <a16:creationId xmlns:a16="http://schemas.microsoft.com/office/drawing/2014/main" id="{F26FAB11-8674-997E-CE5D-CF0FD996C994}"/>
                </a:ext>
              </a:extLst>
            </p:cNvPr>
            <p:cNvSpPr/>
            <p:nvPr/>
          </p:nvSpPr>
          <p:spPr>
            <a:xfrm>
              <a:off x="1196341" y="1288537"/>
              <a:ext cx="701040" cy="360797"/>
            </a:xfrm>
            <a:prstGeom prst="rect">
              <a:avLst/>
            </a:prstGeom>
            <a:noFill/>
            <a:ln w="2857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45" name="직선 연결선 44">
              <a:extLst>
                <a:ext uri="{FF2B5EF4-FFF2-40B4-BE49-F238E27FC236}">
                  <a16:creationId xmlns:a16="http://schemas.microsoft.com/office/drawing/2014/main" id="{8E56455A-A92D-693A-9394-8CA48C133C3D}"/>
                </a:ext>
              </a:extLst>
            </p:cNvPr>
            <p:cNvCxnSpPr>
              <a:cxnSpLocks/>
            </p:cNvCxnSpPr>
            <p:nvPr/>
          </p:nvCxnSpPr>
          <p:spPr>
            <a:xfrm>
              <a:off x="2305050" y="4436779"/>
              <a:ext cx="85605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EC42FE1-852A-2034-A232-E143C5ED73FF}"/>
                </a:ext>
              </a:extLst>
            </p:cNvPr>
            <p:cNvSpPr txBox="1"/>
            <p:nvPr/>
          </p:nvSpPr>
          <p:spPr>
            <a:xfrm>
              <a:off x="3107527" y="4327666"/>
              <a:ext cx="10715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Pith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직선 연결선 46">
              <a:extLst>
                <a:ext uri="{FF2B5EF4-FFF2-40B4-BE49-F238E27FC236}">
                  <a16:creationId xmlns:a16="http://schemas.microsoft.com/office/drawing/2014/main" id="{177B333C-653C-E88B-361C-EF33F80AA39B}"/>
                </a:ext>
              </a:extLst>
            </p:cNvPr>
            <p:cNvCxnSpPr>
              <a:cxnSpLocks/>
            </p:cNvCxnSpPr>
            <p:nvPr/>
          </p:nvCxnSpPr>
          <p:spPr>
            <a:xfrm>
              <a:off x="2852738" y="3496662"/>
              <a:ext cx="30837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DA64699E-78EF-2DA9-5ABF-D549774CEAED}"/>
                </a:ext>
              </a:extLst>
            </p:cNvPr>
            <p:cNvSpPr txBox="1"/>
            <p:nvPr/>
          </p:nvSpPr>
          <p:spPr>
            <a:xfrm>
              <a:off x="3107527" y="3387549"/>
              <a:ext cx="10715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iberous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 cap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직선 연결선 49">
              <a:extLst>
                <a:ext uri="{FF2B5EF4-FFF2-40B4-BE49-F238E27FC236}">
                  <a16:creationId xmlns:a16="http://schemas.microsoft.com/office/drawing/2014/main" id="{EE0BEAB7-123F-D8A8-D4B6-306FECC073D6}"/>
                </a:ext>
              </a:extLst>
            </p:cNvPr>
            <p:cNvCxnSpPr>
              <a:cxnSpLocks/>
            </p:cNvCxnSpPr>
            <p:nvPr/>
          </p:nvCxnSpPr>
          <p:spPr>
            <a:xfrm>
              <a:off x="2767013" y="3653207"/>
              <a:ext cx="39409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B7FF79EC-9E71-B304-C810-716E05BEE9F0}"/>
                </a:ext>
              </a:extLst>
            </p:cNvPr>
            <p:cNvSpPr txBox="1"/>
            <p:nvPr/>
          </p:nvSpPr>
          <p:spPr>
            <a:xfrm>
              <a:off x="3107527" y="3544094"/>
              <a:ext cx="10715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Primary phloem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직선 연결선 52">
              <a:extLst>
                <a:ext uri="{FF2B5EF4-FFF2-40B4-BE49-F238E27FC236}">
                  <a16:creationId xmlns:a16="http://schemas.microsoft.com/office/drawing/2014/main" id="{7AC7CE05-603B-7D07-82C8-E9E622D6747F}"/>
                </a:ext>
              </a:extLst>
            </p:cNvPr>
            <p:cNvCxnSpPr>
              <a:cxnSpLocks/>
            </p:cNvCxnSpPr>
            <p:nvPr/>
          </p:nvCxnSpPr>
          <p:spPr>
            <a:xfrm>
              <a:off x="2619375" y="3793149"/>
              <a:ext cx="54173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FB9A7732-432A-6CBA-05DB-7D80F31FDB6F}"/>
                </a:ext>
              </a:extLst>
            </p:cNvPr>
            <p:cNvSpPr txBox="1"/>
            <p:nvPr/>
          </p:nvSpPr>
          <p:spPr>
            <a:xfrm>
              <a:off x="3107527" y="3684036"/>
              <a:ext cx="10715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Primary xylem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직선 연결선 55">
              <a:extLst>
                <a:ext uri="{FF2B5EF4-FFF2-40B4-BE49-F238E27FC236}">
                  <a16:creationId xmlns:a16="http://schemas.microsoft.com/office/drawing/2014/main" id="{212CC1F0-7043-CF00-C866-6C260E1FE900}"/>
                </a:ext>
              </a:extLst>
            </p:cNvPr>
            <p:cNvCxnSpPr>
              <a:cxnSpLocks/>
            </p:cNvCxnSpPr>
            <p:nvPr/>
          </p:nvCxnSpPr>
          <p:spPr>
            <a:xfrm>
              <a:off x="2576513" y="3995074"/>
              <a:ext cx="58459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D2179A3C-ADD8-8950-9153-BE532DCB7909}"/>
                </a:ext>
              </a:extLst>
            </p:cNvPr>
            <p:cNvSpPr txBox="1"/>
            <p:nvPr/>
          </p:nvSpPr>
          <p:spPr>
            <a:xfrm>
              <a:off x="3107527" y="3885961"/>
              <a:ext cx="10715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Vessel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2" name="TextBox 61">
            <a:extLst>
              <a:ext uri="{FF2B5EF4-FFF2-40B4-BE49-F238E27FC236}">
                <a16:creationId xmlns:a16="http://schemas.microsoft.com/office/drawing/2014/main" id="{A4FE7D10-D4E7-D5D6-798A-86BC9D0BCE98}"/>
              </a:ext>
            </a:extLst>
          </p:cNvPr>
          <p:cNvSpPr txBox="1"/>
          <p:nvPr/>
        </p:nvSpPr>
        <p:spPr>
          <a:xfrm>
            <a:off x="130186" y="5551316"/>
            <a:ext cx="580199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Histochemical and microscopic analysis after removing trichomes from the stem of </a:t>
            </a:r>
            <a:r>
              <a:rPr lang="en-US" altLang="ko-KR" sz="14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Artemisia argyi.</a:t>
            </a:r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A. 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Transverse section of stem. A white square box indicates a part of stem where the trichome is removed. </a:t>
            </a:r>
            <a:r>
              <a:rPr lang="en-US" altLang="ko-KR" sz="1400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B.</a:t>
            </a:r>
            <a:r>
              <a:rPr lang="en-US" altLang="ko-KR" sz="14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Magnified image of stem transverse section showing that trichomes attached onto epidermis are removed.</a:t>
            </a:r>
            <a:endParaRPr lang="ko-KR" altLang="ko-KR" sz="105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8CE9C617-F6CA-4EF7-A67B-BBCAB8111AF3}"/>
              </a:ext>
            </a:extLst>
          </p:cNvPr>
          <p:cNvCxnSpPr/>
          <p:nvPr/>
        </p:nvCxnSpPr>
        <p:spPr>
          <a:xfrm>
            <a:off x="178587" y="473099"/>
            <a:ext cx="6123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A51FF790-DEA0-4B99-B300-20CBEE9D6768}"/>
              </a:ext>
            </a:extLst>
          </p:cNvPr>
          <p:cNvSpPr txBox="1"/>
          <p:nvPr/>
        </p:nvSpPr>
        <p:spPr>
          <a:xfrm>
            <a:off x="116566" y="127192"/>
            <a:ext cx="2092560" cy="4024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15" b="1" dirty="0">
                <a:latin typeface="Calibri" panose="020F0502020204030204" pitchFamily="34" charset="0"/>
                <a:cs typeface="Calibri" panose="020F0502020204030204" pitchFamily="34" charset="0"/>
              </a:rPr>
              <a:t>Figure S1.</a:t>
            </a:r>
          </a:p>
        </p:txBody>
      </p:sp>
    </p:spTree>
    <p:extLst>
      <p:ext uri="{BB962C8B-B14F-4D97-AF65-F5344CB8AC3E}">
        <p14:creationId xmlns:p14="http://schemas.microsoft.com/office/powerpoint/2010/main" val="31457427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그룹 35">
            <a:extLst>
              <a:ext uri="{FF2B5EF4-FFF2-40B4-BE49-F238E27FC236}">
                <a16:creationId xmlns:a16="http://schemas.microsoft.com/office/drawing/2014/main" id="{F41B9F13-F046-E787-BECD-15328DDB4C00}"/>
              </a:ext>
            </a:extLst>
          </p:cNvPr>
          <p:cNvGrpSpPr/>
          <p:nvPr/>
        </p:nvGrpSpPr>
        <p:grpSpPr>
          <a:xfrm>
            <a:off x="442608" y="2112047"/>
            <a:ext cx="5392823" cy="5324388"/>
            <a:chOff x="442608" y="2112047"/>
            <a:chExt cx="5392823" cy="5324388"/>
          </a:xfrm>
        </p:grpSpPr>
        <p:grpSp>
          <p:nvGrpSpPr>
            <p:cNvPr id="19" name="그룹 18">
              <a:extLst>
                <a:ext uri="{FF2B5EF4-FFF2-40B4-BE49-F238E27FC236}">
                  <a16:creationId xmlns:a16="http://schemas.microsoft.com/office/drawing/2014/main" id="{06CF6437-AA1E-65E2-D34D-2FEA0639DD36}"/>
                </a:ext>
              </a:extLst>
            </p:cNvPr>
            <p:cNvGrpSpPr/>
            <p:nvPr/>
          </p:nvGrpSpPr>
          <p:grpSpPr>
            <a:xfrm>
              <a:off x="442608" y="2148685"/>
              <a:ext cx="5392823" cy="5287750"/>
              <a:chOff x="1480496" y="-161538"/>
              <a:chExt cx="7177846" cy="7037996"/>
            </a:xfrm>
          </p:grpSpPr>
          <p:pic>
            <p:nvPicPr>
              <p:cNvPr id="24" name="그림 23">
                <a:extLst>
                  <a:ext uri="{FF2B5EF4-FFF2-40B4-BE49-F238E27FC236}">
                    <a16:creationId xmlns:a16="http://schemas.microsoft.com/office/drawing/2014/main" id="{3673D74D-6051-9A78-3132-2ACECB29345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001297" y="3338474"/>
                <a:ext cx="3537984" cy="3537984"/>
              </a:xfrm>
              <a:prstGeom prst="rect">
                <a:avLst/>
              </a:prstGeom>
            </p:spPr>
          </p:pic>
          <p:pic>
            <p:nvPicPr>
              <p:cNvPr id="25" name="그림 24">
                <a:extLst>
                  <a:ext uri="{FF2B5EF4-FFF2-40B4-BE49-F238E27FC236}">
                    <a16:creationId xmlns:a16="http://schemas.microsoft.com/office/drawing/2014/main" id="{821D0C21-15B6-DA19-78A4-B7A831F830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001297" y="-161538"/>
                <a:ext cx="3537984" cy="3537984"/>
              </a:xfrm>
              <a:prstGeom prst="rect">
                <a:avLst/>
              </a:prstGeom>
            </p:spPr>
          </p:pic>
          <p:pic>
            <p:nvPicPr>
              <p:cNvPr id="26" name="그림 25">
                <a:extLst>
                  <a:ext uri="{FF2B5EF4-FFF2-40B4-BE49-F238E27FC236}">
                    <a16:creationId xmlns:a16="http://schemas.microsoft.com/office/drawing/2014/main" id="{D141F47A-F0C1-98DD-547D-8473817C443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208617" y="26638"/>
                <a:ext cx="2449725" cy="2807640"/>
              </a:xfrm>
              <a:prstGeom prst="rect">
                <a:avLst/>
              </a:prstGeom>
            </p:spPr>
          </p:pic>
          <p:pic>
            <p:nvPicPr>
              <p:cNvPr id="27" name="그림 26">
                <a:extLst>
                  <a:ext uri="{FF2B5EF4-FFF2-40B4-BE49-F238E27FC236}">
                    <a16:creationId xmlns:a16="http://schemas.microsoft.com/office/drawing/2014/main" id="{DC604D50-FE0F-DD8E-C012-C3473F948B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211535" y="3547134"/>
                <a:ext cx="2443887" cy="2808881"/>
              </a:xfrm>
              <a:prstGeom prst="rect">
                <a:avLst/>
              </a:prstGeom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204F7371-E4A0-4AB2-2B5B-2A6B3FDB0A27}"/>
                  </a:ext>
                </a:extLst>
              </p:cNvPr>
              <p:cNvSpPr txBox="1"/>
              <p:nvPr/>
            </p:nvSpPr>
            <p:spPr>
              <a:xfrm>
                <a:off x="1480496" y="142359"/>
                <a:ext cx="914399" cy="4506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kumimoji="1" lang="ko-Kore-KR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938987C7-3F2D-1E57-4FEA-7BE196FF602F}"/>
                  </a:ext>
                </a:extLst>
              </p:cNvPr>
              <p:cNvSpPr txBox="1"/>
              <p:nvPr/>
            </p:nvSpPr>
            <p:spPr>
              <a:xfrm>
                <a:off x="5573723" y="142359"/>
                <a:ext cx="914399" cy="4506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ko-Kore-KR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7E261DBE-2669-58DD-6706-C9EEC9421CDC}"/>
                  </a:ext>
                </a:extLst>
              </p:cNvPr>
              <p:cNvSpPr txBox="1"/>
              <p:nvPr/>
            </p:nvSpPr>
            <p:spPr>
              <a:xfrm>
                <a:off x="1480496" y="3634926"/>
                <a:ext cx="914399" cy="4506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kumimoji="1" lang="ko-Kore-KR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1F66130D-7E9C-AD9E-E2E2-D256AABE1700}"/>
                  </a:ext>
                </a:extLst>
              </p:cNvPr>
              <p:cNvSpPr txBox="1"/>
              <p:nvPr/>
            </p:nvSpPr>
            <p:spPr>
              <a:xfrm>
                <a:off x="5573723" y="3634926"/>
                <a:ext cx="914399" cy="4506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kumimoji="1" lang="ko-Kore-KR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7B7B5A1-4271-E421-89A3-A70A190B4CFC}"/>
                </a:ext>
              </a:extLst>
            </p:cNvPr>
            <p:cNvSpPr txBox="1"/>
            <p:nvPr/>
          </p:nvSpPr>
          <p:spPr>
            <a:xfrm>
              <a:off x="1018830" y="2156432"/>
              <a:ext cx="238942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Young leaves  vs  Old leaves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189DD66-B39B-7EB8-D23D-50792051C9B1}"/>
                </a:ext>
              </a:extLst>
            </p:cNvPr>
            <p:cNvSpPr txBox="1"/>
            <p:nvPr/>
          </p:nvSpPr>
          <p:spPr>
            <a:xfrm>
              <a:off x="1293009" y="4796566"/>
              <a:ext cx="173990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richome  vs  Stem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직사각형 32">
              <a:extLst>
                <a:ext uri="{FF2B5EF4-FFF2-40B4-BE49-F238E27FC236}">
                  <a16:creationId xmlns:a16="http://schemas.microsoft.com/office/drawing/2014/main" id="{C4CD341E-9A95-6775-16CA-6F4B0D8A20ED}"/>
                </a:ext>
              </a:extLst>
            </p:cNvPr>
            <p:cNvSpPr/>
            <p:nvPr/>
          </p:nvSpPr>
          <p:spPr>
            <a:xfrm>
              <a:off x="4075043" y="2112047"/>
              <a:ext cx="1162879" cy="39095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E48AC72-CB2A-9AC8-BBA7-BF95411C6E58}"/>
                </a:ext>
              </a:extLst>
            </p:cNvPr>
            <p:cNvSpPr txBox="1"/>
            <p:nvPr/>
          </p:nvSpPr>
          <p:spPr>
            <a:xfrm>
              <a:off x="3368501" y="2156432"/>
              <a:ext cx="238942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Young leaves   Old leaves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직사각형 33">
              <a:extLst>
                <a:ext uri="{FF2B5EF4-FFF2-40B4-BE49-F238E27FC236}">
                  <a16:creationId xmlns:a16="http://schemas.microsoft.com/office/drawing/2014/main" id="{CA68C083-9801-8060-9425-13C2D65992CF}"/>
                </a:ext>
              </a:extLst>
            </p:cNvPr>
            <p:cNvSpPr/>
            <p:nvPr/>
          </p:nvSpPr>
          <p:spPr>
            <a:xfrm>
              <a:off x="4075043" y="4744516"/>
              <a:ext cx="1162879" cy="39095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5F18317D-5546-0DFE-C5FF-C303582610EC}"/>
                </a:ext>
              </a:extLst>
            </p:cNvPr>
            <p:cNvSpPr txBox="1"/>
            <p:nvPr/>
          </p:nvSpPr>
          <p:spPr>
            <a:xfrm>
              <a:off x="3693260" y="4788467"/>
              <a:ext cx="173990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richome    Stem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8AF19071-EDE2-4530-8637-54CAEBE38466}"/>
              </a:ext>
            </a:extLst>
          </p:cNvPr>
          <p:cNvCxnSpPr/>
          <p:nvPr/>
        </p:nvCxnSpPr>
        <p:spPr>
          <a:xfrm>
            <a:off x="178587" y="473099"/>
            <a:ext cx="6123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81745A27-0BE4-40A5-863A-B17AACD77FB6}"/>
              </a:ext>
            </a:extLst>
          </p:cNvPr>
          <p:cNvSpPr txBox="1"/>
          <p:nvPr/>
        </p:nvSpPr>
        <p:spPr>
          <a:xfrm>
            <a:off x="116566" y="127192"/>
            <a:ext cx="2092560" cy="4024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15" b="1" dirty="0">
                <a:latin typeface="Calibri" panose="020F0502020204030204" pitchFamily="34" charset="0"/>
                <a:cs typeface="Calibri" panose="020F0502020204030204" pitchFamily="34" charset="0"/>
              </a:rPr>
              <a:t>Figure S2.</a:t>
            </a: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F3118739-1A85-4F9F-912B-FBC5223D0ADD}"/>
              </a:ext>
            </a:extLst>
          </p:cNvPr>
          <p:cNvSpPr/>
          <p:nvPr/>
        </p:nvSpPr>
        <p:spPr>
          <a:xfrm>
            <a:off x="155405" y="7883746"/>
            <a:ext cx="6123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Number of differentially expressed genes for each pairwise comparison. MA-plot for differentially expressed genes between </a:t>
            </a:r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A.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young and old leaves </a:t>
            </a:r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B.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trichome and stem. The number of up- or down- regulated genes between </a:t>
            </a:r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C.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young and old leaves </a:t>
            </a:r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D.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trichome and stem is shown respectively.</a:t>
            </a:r>
            <a:endParaRPr lang="ko-KR" altLang="en-US" sz="1200" dirty="0"/>
          </a:p>
          <a:p>
            <a:pPr algn="just"/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14108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그룹 14">
            <a:extLst>
              <a:ext uri="{FF2B5EF4-FFF2-40B4-BE49-F238E27FC236}">
                <a16:creationId xmlns:a16="http://schemas.microsoft.com/office/drawing/2014/main" id="{0598441B-BF35-AE90-F039-FF27F75908DE}"/>
              </a:ext>
            </a:extLst>
          </p:cNvPr>
          <p:cNvGrpSpPr/>
          <p:nvPr/>
        </p:nvGrpSpPr>
        <p:grpSpPr>
          <a:xfrm>
            <a:off x="313995" y="2244469"/>
            <a:ext cx="5852183" cy="4187306"/>
            <a:chOff x="373992" y="2181839"/>
            <a:chExt cx="5852183" cy="4187306"/>
          </a:xfrm>
        </p:grpSpPr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51437A88-5DB3-CFA4-FE66-93138BCE27E0}"/>
                </a:ext>
              </a:extLst>
            </p:cNvPr>
            <p:cNvGrpSpPr/>
            <p:nvPr/>
          </p:nvGrpSpPr>
          <p:grpSpPr>
            <a:xfrm>
              <a:off x="373992" y="2181839"/>
              <a:ext cx="5732189" cy="4187306"/>
              <a:chOff x="1530934" y="0"/>
              <a:chExt cx="9231750" cy="6743700"/>
            </a:xfrm>
          </p:grpSpPr>
          <p:pic>
            <p:nvPicPr>
              <p:cNvPr id="10" name="그림 9">
                <a:extLst>
                  <a:ext uri="{FF2B5EF4-FFF2-40B4-BE49-F238E27FC236}">
                    <a16:creationId xmlns:a16="http://schemas.microsoft.com/office/drawing/2014/main" id="{A4D0463C-89C3-652D-3CFB-F2EF1F99CFD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67175" y="0"/>
                <a:ext cx="9195509" cy="3197316"/>
              </a:xfrm>
              <a:prstGeom prst="rect">
                <a:avLst/>
              </a:prstGeom>
            </p:spPr>
          </p:pic>
          <p:pic>
            <p:nvPicPr>
              <p:cNvPr id="11" name="그림 10">
                <a:extLst>
                  <a:ext uri="{FF2B5EF4-FFF2-40B4-BE49-F238E27FC236}">
                    <a16:creationId xmlns:a16="http://schemas.microsoft.com/office/drawing/2014/main" id="{95CED2D1-7E2A-712C-1236-828F18BD61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48529" y="3660685"/>
                <a:ext cx="8096244" cy="3083015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9E17D39B-A317-C722-13EF-12137C6157EF}"/>
                  </a:ext>
                </a:extLst>
              </p:cNvPr>
              <p:cNvSpPr txBox="1"/>
              <p:nvPr/>
            </p:nvSpPr>
            <p:spPr>
              <a:xfrm>
                <a:off x="1530934" y="0"/>
                <a:ext cx="635190" cy="4956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ko-KR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1A3F6EA8-B8AD-5C45-A067-11CA3FF47EA6}"/>
                  </a:ext>
                </a:extLst>
              </p:cNvPr>
              <p:cNvSpPr txBox="1"/>
              <p:nvPr/>
            </p:nvSpPr>
            <p:spPr>
              <a:xfrm>
                <a:off x="1530934" y="3660685"/>
                <a:ext cx="635190" cy="4956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ko-KR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9B2B243-A3CA-23A4-A934-08755432B75F}"/>
                </a:ext>
              </a:extLst>
            </p:cNvPr>
            <p:cNvSpPr txBox="1"/>
            <p:nvPr/>
          </p:nvSpPr>
          <p:spPr>
            <a:xfrm>
              <a:off x="1374595" y="2200950"/>
              <a:ext cx="226387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Young leaves vs Old leaves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214BF01-C93B-8D3A-F026-378D6308E31C}"/>
                </a:ext>
              </a:extLst>
            </p:cNvPr>
            <p:cNvSpPr txBox="1"/>
            <p:nvPr/>
          </p:nvSpPr>
          <p:spPr>
            <a:xfrm>
              <a:off x="4007758" y="2200950"/>
              <a:ext cx="210849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richome vs Stem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직사각형 13">
              <a:extLst>
                <a:ext uri="{FF2B5EF4-FFF2-40B4-BE49-F238E27FC236}">
                  <a16:creationId xmlns:a16="http://schemas.microsoft.com/office/drawing/2014/main" id="{A22F1CE4-0650-5DC6-C112-031E24FEFDEA}"/>
                </a:ext>
              </a:extLst>
            </p:cNvPr>
            <p:cNvSpPr/>
            <p:nvPr/>
          </p:nvSpPr>
          <p:spPr>
            <a:xfrm>
              <a:off x="4458431" y="5683250"/>
              <a:ext cx="678719" cy="3195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B6FA73C-5CC9-F179-EC0D-5CAF4A81909A}"/>
                </a:ext>
              </a:extLst>
            </p:cNvPr>
            <p:cNvSpPr txBox="1"/>
            <p:nvPr/>
          </p:nvSpPr>
          <p:spPr>
            <a:xfrm>
              <a:off x="4398106" y="5639262"/>
              <a:ext cx="18280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oung leaves vs Old leaves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37B96EA-ADC2-BA54-E552-7A5855284C52}"/>
                </a:ext>
              </a:extLst>
            </p:cNvPr>
            <p:cNvSpPr txBox="1"/>
            <p:nvPr/>
          </p:nvSpPr>
          <p:spPr>
            <a:xfrm>
              <a:off x="4398106" y="5830367"/>
              <a:ext cx="18280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richome vs Stem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01BB1D1F-FA4D-4827-A0AE-156E781B2C9F}"/>
              </a:ext>
            </a:extLst>
          </p:cNvPr>
          <p:cNvCxnSpPr/>
          <p:nvPr/>
        </p:nvCxnSpPr>
        <p:spPr>
          <a:xfrm>
            <a:off x="178587" y="473099"/>
            <a:ext cx="6123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BC38FF3D-7DAC-4539-8233-A9A6158BF36B}"/>
              </a:ext>
            </a:extLst>
          </p:cNvPr>
          <p:cNvSpPr txBox="1"/>
          <p:nvPr/>
        </p:nvSpPr>
        <p:spPr>
          <a:xfrm>
            <a:off x="116566" y="127192"/>
            <a:ext cx="2092560" cy="4024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15" b="1" dirty="0">
                <a:latin typeface="Calibri" panose="020F0502020204030204" pitchFamily="34" charset="0"/>
                <a:cs typeface="Calibri" panose="020F0502020204030204" pitchFamily="34" charset="0"/>
              </a:rPr>
              <a:t>Figure S3.</a:t>
            </a: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D5560290-4B30-4ED8-8DC4-CAD71EF77F9D}"/>
              </a:ext>
            </a:extLst>
          </p:cNvPr>
          <p:cNvSpPr/>
          <p:nvPr/>
        </p:nvSpPr>
        <p:spPr>
          <a:xfrm>
            <a:off x="58282" y="7404866"/>
            <a:ext cx="6363609" cy="15388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Kyoto Encyclopedia of Genes and Genome (KEGG) pathway analysis of differentially expressed genes (DEGs). </a:t>
            </a:r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KEGG pathway classification of DEGs. </a:t>
            </a:r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Up-regulated DEGs of “Biosynthesis of other secondary metabolites" category in young leaves vs. old leaves and trichome vs. stem (Grey box of </a:t>
            </a:r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anel). The red bar indicates up-regulated DEGs, and the blue bar indicates down-regulated DEGs. The green bar in </a:t>
            </a:r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hows up-regulated DEGs of "biosynthesis of other secondary metabolites" category in young leaves vs. old leaves. The yellow bar also indicates up-regulated DEGs of "biosynthesis of other secondary metabolites" category in trichome vs. stem. 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/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17622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A4CA5EAE-1825-7F64-1546-9C73DC9C2373}"/>
              </a:ext>
            </a:extLst>
          </p:cNvPr>
          <p:cNvGrpSpPr/>
          <p:nvPr/>
        </p:nvGrpSpPr>
        <p:grpSpPr>
          <a:xfrm>
            <a:off x="282797" y="1921237"/>
            <a:ext cx="5914581" cy="3991190"/>
            <a:chOff x="1464633" y="226445"/>
            <a:chExt cx="9525492" cy="6427852"/>
          </a:xfrm>
        </p:grpSpPr>
        <p:grpSp>
          <p:nvGrpSpPr>
            <p:cNvPr id="8" name="그룹 7">
              <a:extLst>
                <a:ext uri="{FF2B5EF4-FFF2-40B4-BE49-F238E27FC236}">
                  <a16:creationId xmlns:a16="http://schemas.microsoft.com/office/drawing/2014/main" id="{A9A178AE-D9E2-9BA2-0B55-1B6837BBF0B1}"/>
                </a:ext>
              </a:extLst>
            </p:cNvPr>
            <p:cNvGrpSpPr/>
            <p:nvPr/>
          </p:nvGrpSpPr>
          <p:grpSpPr>
            <a:xfrm>
              <a:off x="1464633" y="686763"/>
              <a:ext cx="9525492" cy="5967534"/>
              <a:chOff x="270832" y="-292367"/>
              <a:chExt cx="11413561" cy="7150372"/>
            </a:xfrm>
          </p:grpSpPr>
          <p:pic>
            <p:nvPicPr>
              <p:cNvPr id="11" name="그림 10">
                <a:extLst>
                  <a:ext uri="{FF2B5EF4-FFF2-40B4-BE49-F238E27FC236}">
                    <a16:creationId xmlns:a16="http://schemas.microsoft.com/office/drawing/2014/main" id="{0AD31A81-C202-9CCA-583E-5B72159D132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019"/>
              <a:stretch/>
            </p:blipFill>
            <p:spPr>
              <a:xfrm rot="5400000">
                <a:off x="-715619" y="694084"/>
                <a:ext cx="7150369" cy="5177467"/>
              </a:xfrm>
              <a:prstGeom prst="rect">
                <a:avLst/>
              </a:prstGeom>
            </p:spPr>
          </p:pic>
          <p:pic>
            <p:nvPicPr>
              <p:cNvPr id="12" name="그림 11">
                <a:extLst>
                  <a:ext uri="{FF2B5EF4-FFF2-40B4-BE49-F238E27FC236}">
                    <a16:creationId xmlns:a16="http://schemas.microsoft.com/office/drawing/2014/main" id="{74AA0CD0-F3D2-F3CE-5FFA-7C05DA4C359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-66" r="6323"/>
              <a:stretch/>
            </p:blipFill>
            <p:spPr>
              <a:xfrm rot="5400000">
                <a:off x="5203895" y="377507"/>
                <a:ext cx="7150371" cy="5810625"/>
              </a:xfrm>
              <a:prstGeom prst="rect">
                <a:avLst/>
              </a:prstGeom>
            </p:spPr>
          </p:pic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8D7B5EA-15BB-BE5D-E966-07AE1E9B02BB}"/>
                </a:ext>
              </a:extLst>
            </p:cNvPr>
            <p:cNvSpPr txBox="1"/>
            <p:nvPr/>
          </p:nvSpPr>
          <p:spPr>
            <a:xfrm>
              <a:off x="1688781" y="226447"/>
              <a:ext cx="4258559" cy="47089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300" b="1" dirty="0">
                  <a:latin typeface="Arial" panose="020B0604020202020204" pitchFamily="34" charset="0"/>
                  <a:cs typeface="Arial" panose="020B0604020202020204" pitchFamily="34" charset="0"/>
                </a:rPr>
                <a:t>Young leaves  vs  Old leaves</a:t>
              </a:r>
              <a:endParaRPr lang="ko-KR" alt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215D85D-45DF-A299-0EA0-459F2B02416C}"/>
                </a:ext>
              </a:extLst>
            </p:cNvPr>
            <p:cNvSpPr txBox="1"/>
            <p:nvPr/>
          </p:nvSpPr>
          <p:spPr>
            <a:xfrm>
              <a:off x="6822829" y="226445"/>
              <a:ext cx="3291807" cy="47089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300" b="1" dirty="0">
                  <a:latin typeface="Arial" panose="020B0604020202020204" pitchFamily="34" charset="0"/>
                  <a:cs typeface="Arial" panose="020B0604020202020204" pitchFamily="34" charset="0"/>
                </a:rPr>
                <a:t>Trichome  vs  Stem</a:t>
              </a:r>
              <a:endParaRPr lang="ko-KR" altLang="en-US" sz="1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96F915FD-4FE0-48F9-B128-1B9A76B3A3F4}"/>
              </a:ext>
            </a:extLst>
          </p:cNvPr>
          <p:cNvCxnSpPr/>
          <p:nvPr/>
        </p:nvCxnSpPr>
        <p:spPr>
          <a:xfrm>
            <a:off x="178587" y="473099"/>
            <a:ext cx="6123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68B7EFA9-A71A-4598-BC3B-2BB54A334E15}"/>
              </a:ext>
            </a:extLst>
          </p:cNvPr>
          <p:cNvSpPr txBox="1"/>
          <p:nvPr/>
        </p:nvSpPr>
        <p:spPr>
          <a:xfrm>
            <a:off x="116566" y="127192"/>
            <a:ext cx="2092560" cy="4024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15" b="1" dirty="0">
                <a:latin typeface="Calibri" panose="020F0502020204030204" pitchFamily="34" charset="0"/>
                <a:cs typeface="Calibri" panose="020F0502020204030204" pitchFamily="34" charset="0"/>
              </a:rPr>
              <a:t>Figure S4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157DC73-F8FE-4D78-993D-3ECD9936590E}"/>
              </a:ext>
            </a:extLst>
          </p:cNvPr>
          <p:cNvSpPr txBox="1"/>
          <p:nvPr/>
        </p:nvSpPr>
        <p:spPr>
          <a:xfrm>
            <a:off x="313995" y="2244469"/>
            <a:ext cx="394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5758003-5477-45D3-8F3F-BB889B2FC5C9}"/>
              </a:ext>
            </a:extLst>
          </p:cNvPr>
          <p:cNvSpPr txBox="1"/>
          <p:nvPr/>
        </p:nvSpPr>
        <p:spPr>
          <a:xfrm>
            <a:off x="3412613" y="2244469"/>
            <a:ext cx="394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8E3F419F-6039-416F-98CA-8FD98877EC2D}"/>
              </a:ext>
            </a:extLst>
          </p:cNvPr>
          <p:cNvSpPr/>
          <p:nvPr/>
        </p:nvSpPr>
        <p:spPr>
          <a:xfrm>
            <a:off x="37255" y="7488737"/>
            <a:ext cx="612299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Gene Ontology (GO) enrichment analysis of differentially expressed genes (DEGs). The 20 most GO enriched terms are listed in order of significance in the DEG sets of </a:t>
            </a:r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A.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young leaves vs. old leaves, and </a:t>
            </a:r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B.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trichome vs. stem. 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30021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0">
            <a:extLst>
              <a:ext uri="{FF2B5EF4-FFF2-40B4-BE49-F238E27FC236}">
                <a16:creationId xmlns:a16="http://schemas.microsoft.com/office/drawing/2014/main" id="{E75968E0-6FFA-42FE-B372-C160DA73716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6566" y="3694347"/>
            <a:ext cx="3456228" cy="2861487"/>
          </a:xfrm>
          <a:prstGeom prst="rect">
            <a:avLst/>
          </a:prstGeom>
        </p:spPr>
      </p:pic>
      <p:pic>
        <p:nvPicPr>
          <p:cNvPr id="32" name="Picture 5" descr="Diagram, venn diagram&#10;&#10;Description automatically generated">
            <a:extLst>
              <a:ext uri="{FF2B5EF4-FFF2-40B4-BE49-F238E27FC236}">
                <a16:creationId xmlns:a16="http://schemas.microsoft.com/office/drawing/2014/main" id="{EE7AA998-0C60-4B48-86F1-D830A1D92D5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1"/>
          <a:stretch/>
        </p:blipFill>
        <p:spPr>
          <a:xfrm>
            <a:off x="226389" y="1156273"/>
            <a:ext cx="2871113" cy="2481564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C97DFDF0-9756-4EB9-B1E5-155A65B05998}"/>
              </a:ext>
            </a:extLst>
          </p:cNvPr>
          <p:cNvSpPr txBox="1"/>
          <p:nvPr/>
        </p:nvSpPr>
        <p:spPr>
          <a:xfrm>
            <a:off x="1064633" y="3138142"/>
            <a:ext cx="12151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otal: 7,265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5951251-F47B-4DBC-BE40-BE84CDB5A931}"/>
              </a:ext>
            </a:extLst>
          </p:cNvPr>
          <p:cNvSpPr txBox="1"/>
          <p:nvPr/>
        </p:nvSpPr>
        <p:spPr>
          <a:xfrm>
            <a:off x="69134" y="64029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E731625-57F0-402D-9742-F66DB5206F58}"/>
              </a:ext>
            </a:extLst>
          </p:cNvPr>
          <p:cNvSpPr txBox="1"/>
          <p:nvPr/>
        </p:nvSpPr>
        <p:spPr>
          <a:xfrm>
            <a:off x="177710" y="340986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56664DC-1CDB-487F-8872-1E63F45A9ABA}"/>
              </a:ext>
            </a:extLst>
          </p:cNvPr>
          <p:cNvSpPr txBox="1"/>
          <p:nvPr/>
        </p:nvSpPr>
        <p:spPr>
          <a:xfrm>
            <a:off x="-52068" y="892940"/>
            <a:ext cx="1521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richome vs Stem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40240AC-02E2-4A7E-9A94-A7F0C04A6F9C}"/>
              </a:ext>
            </a:extLst>
          </p:cNvPr>
          <p:cNvSpPr txBox="1"/>
          <p:nvPr/>
        </p:nvSpPr>
        <p:spPr>
          <a:xfrm>
            <a:off x="1408855" y="892939"/>
            <a:ext cx="22092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Young leaves vs Old leave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4F450B0E-A4DE-4CFE-BA57-1061E672D922}"/>
              </a:ext>
            </a:extLst>
          </p:cNvPr>
          <p:cNvCxnSpPr/>
          <p:nvPr/>
        </p:nvCxnSpPr>
        <p:spPr>
          <a:xfrm>
            <a:off x="178587" y="473099"/>
            <a:ext cx="6123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04481644-FA28-41B0-8384-68F80EC9B8D8}"/>
              </a:ext>
            </a:extLst>
          </p:cNvPr>
          <p:cNvSpPr txBox="1"/>
          <p:nvPr/>
        </p:nvSpPr>
        <p:spPr>
          <a:xfrm>
            <a:off x="116566" y="127192"/>
            <a:ext cx="2092560" cy="4024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15" b="1" dirty="0">
                <a:latin typeface="Calibri" panose="020F0502020204030204" pitchFamily="34" charset="0"/>
                <a:cs typeface="Calibri" panose="020F0502020204030204" pitchFamily="34" charset="0"/>
              </a:rPr>
              <a:t>Figure S5.</a:t>
            </a: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D88B1B13-A39C-4619-9D26-E88163FC6311}"/>
              </a:ext>
            </a:extLst>
          </p:cNvPr>
          <p:cNvSpPr/>
          <p:nvPr/>
        </p:nvSpPr>
        <p:spPr>
          <a:xfrm>
            <a:off x="0" y="7398807"/>
            <a:ext cx="6480175" cy="8002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ighted gene co-expression network analysis (WGCNA) of 7,265 differentially expressed genes (DEGs). </a:t>
            </a:r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enn diagram analysis of DEGs. </a:t>
            </a:r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Hierarchical cluster tree generated via WGCNA, and each leaf represent one gene. 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/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75514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C95D42E-6162-4349-9E32-EA1E16FCF229}"/>
              </a:ext>
            </a:extLst>
          </p:cNvPr>
          <p:cNvSpPr txBox="1"/>
          <p:nvPr/>
        </p:nvSpPr>
        <p:spPr>
          <a:xfrm>
            <a:off x="1252718" y="3878987"/>
            <a:ext cx="39747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800" dirty="0"/>
              <a:t>Supplementary table</a:t>
            </a:r>
            <a:endParaRPr lang="ko-KR" altLang="en-US" sz="2800" dirty="0"/>
          </a:p>
        </p:txBody>
      </p:sp>
    </p:spTree>
    <p:extLst>
      <p:ext uri="{BB962C8B-B14F-4D97-AF65-F5344CB8AC3E}">
        <p14:creationId xmlns:p14="http://schemas.microsoft.com/office/powerpoint/2010/main" val="2385982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AC09C445-A49E-482B-A167-54267AFFDB1E}"/>
              </a:ext>
            </a:extLst>
          </p:cNvPr>
          <p:cNvSpPr/>
          <p:nvPr/>
        </p:nvSpPr>
        <p:spPr>
          <a:xfrm>
            <a:off x="531177" y="3111698"/>
            <a:ext cx="577040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assembled transcripts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ngth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표 7">
            <a:extLst>
              <a:ext uri="{FF2B5EF4-FFF2-40B4-BE49-F238E27FC236}">
                <a16:creationId xmlns:a16="http://schemas.microsoft.com/office/drawing/2014/main" id="{C3CE0F1F-22C3-4C41-8FB2-8DFCE692E913}"/>
              </a:ext>
            </a:extLst>
          </p:cNvPr>
          <p:cNvGraphicFramePr>
            <a:graphicFrameLocks noGrp="1"/>
          </p:cNvGraphicFramePr>
          <p:nvPr/>
        </p:nvGraphicFramePr>
        <p:xfrm>
          <a:off x="625158" y="3419476"/>
          <a:ext cx="4487861" cy="25774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24560">
                  <a:extLst>
                    <a:ext uri="{9D8B030D-6E8A-4147-A177-3AD203B41FA5}">
                      <a16:colId xmlns:a16="http://schemas.microsoft.com/office/drawing/2014/main" val="201728672"/>
                    </a:ext>
                  </a:extLst>
                </a:gridCol>
                <a:gridCol w="1342029">
                  <a:extLst>
                    <a:ext uri="{9D8B030D-6E8A-4147-A177-3AD203B41FA5}">
                      <a16:colId xmlns:a16="http://schemas.microsoft.com/office/drawing/2014/main" val="3679918898"/>
                    </a:ext>
                  </a:extLst>
                </a:gridCol>
                <a:gridCol w="2121272">
                  <a:extLst>
                    <a:ext uri="{9D8B030D-6E8A-4147-A177-3AD203B41FA5}">
                      <a16:colId xmlns:a16="http://schemas.microsoft.com/office/drawing/2014/main" val="3609597022"/>
                    </a:ext>
                  </a:extLst>
                </a:gridCol>
              </a:tblGrid>
              <a:tr h="23431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</a:rPr>
                        <a:t>Length (bp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</a:rPr>
                        <a:t>Total transcript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</a:rPr>
                        <a:t>Representative transcript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9417187"/>
                  </a:ext>
                </a:extLst>
              </a:tr>
              <a:tr h="23431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500~1,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mpd="sng"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47,45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mpd="sng"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21,41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T w="12700" cmpd="sng">
                      <a:noFill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8652372"/>
                  </a:ext>
                </a:extLst>
              </a:tr>
              <a:tr h="23431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1,001~1,50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25,402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8,38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3807003"/>
                  </a:ext>
                </a:extLst>
              </a:tr>
              <a:tr h="23431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1,501~2,00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17,07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5,36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8664366"/>
                  </a:ext>
                </a:extLst>
              </a:tr>
              <a:tr h="23431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2,001~2,50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9,63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2,895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7752278"/>
                  </a:ext>
                </a:extLst>
              </a:tr>
              <a:tr h="23431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2,501~3,00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5,171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1,47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1715151"/>
                  </a:ext>
                </a:extLst>
              </a:tr>
              <a:tr h="23431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3,001~3,50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2,86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82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8527528"/>
                  </a:ext>
                </a:extLst>
              </a:tr>
              <a:tr h="23431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3,501~4,00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1,533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44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9572155"/>
                  </a:ext>
                </a:extLst>
              </a:tr>
              <a:tr h="23431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4,001~4,5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69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207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5675554"/>
                  </a:ext>
                </a:extLst>
              </a:tr>
              <a:tr h="23431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4,500~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1,109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368 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4827850"/>
                  </a:ext>
                </a:extLst>
              </a:tr>
              <a:tr h="23431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</a:rPr>
                        <a:t>Tota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u="none" strike="noStrike" dirty="0">
                          <a:effectLst/>
                        </a:rPr>
                        <a:t>110,940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u="none" strike="noStrike" dirty="0">
                          <a:effectLst/>
                        </a:rPr>
                        <a:t>41,398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066381"/>
                  </a:ext>
                </a:extLst>
              </a:tr>
            </a:tbl>
          </a:graphicData>
        </a:graphic>
      </p:graphicFrame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42BF8988-26EE-4DE3-9FD6-E1C33E63E753}"/>
              </a:ext>
            </a:extLst>
          </p:cNvPr>
          <p:cNvCxnSpPr/>
          <p:nvPr/>
        </p:nvCxnSpPr>
        <p:spPr>
          <a:xfrm>
            <a:off x="178587" y="473099"/>
            <a:ext cx="6123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032E66A4-B1D6-4945-8BBC-F999BF762139}"/>
              </a:ext>
            </a:extLst>
          </p:cNvPr>
          <p:cNvSpPr txBox="1"/>
          <p:nvPr/>
        </p:nvSpPr>
        <p:spPr>
          <a:xfrm>
            <a:off x="116566" y="127192"/>
            <a:ext cx="2092560" cy="4024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15" b="1" dirty="0">
                <a:latin typeface="Calibri" panose="020F0502020204030204" pitchFamily="34" charset="0"/>
                <a:cs typeface="Calibri" panose="020F0502020204030204" pitchFamily="34" charset="0"/>
              </a:rPr>
              <a:t>Table S1.</a:t>
            </a:r>
          </a:p>
        </p:txBody>
      </p:sp>
    </p:spTree>
    <p:extLst>
      <p:ext uri="{BB962C8B-B14F-4D97-AF65-F5344CB8AC3E}">
        <p14:creationId xmlns:p14="http://schemas.microsoft.com/office/powerpoint/2010/main" val="1556774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246</TotalTime>
  <Words>482</Words>
  <Application>Microsoft Office PowerPoint</Application>
  <PresentationFormat>Custom</PresentationFormat>
  <Paragraphs>90</Paragraphs>
  <Slides>8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맑은 고딕</vt:lpstr>
      <vt:lpstr>Arial</vt:lpstr>
      <vt:lpstr>Arial</vt:lpstr>
      <vt:lpstr>Calibri</vt:lpstr>
      <vt:lpstr>Calibri Light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 SUHYEON</dc:creator>
  <cp:lastModifiedBy>Tim West</cp:lastModifiedBy>
  <cp:revision>647</cp:revision>
  <cp:lastPrinted>2023-02-23T10:56:38Z</cp:lastPrinted>
  <dcterms:created xsi:type="dcterms:W3CDTF">2022-01-11T06:41:16Z</dcterms:created>
  <dcterms:modified xsi:type="dcterms:W3CDTF">2023-04-10T11:29:50Z</dcterms:modified>
</cp:coreProperties>
</file>